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9A46"/>
    <a:srgbClr val="0000FF"/>
    <a:srgbClr val="66FF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5395" autoAdjust="0"/>
    <p:restoredTop sz="94660"/>
  </p:normalViewPr>
  <p:slideViewPr>
    <p:cSldViewPr snapToGrid="0">
      <p:cViewPr varScale="1">
        <p:scale>
          <a:sx n="75" d="100"/>
          <a:sy n="75" d="100"/>
        </p:scale>
        <p:origin x="60" y="8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40" d="100"/>
        <a:sy n="14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70A58A-64E3-47CB-9175-2A40CF78FE7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3FDF957-D196-400B-A8C7-A921E628A40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BA4C7E-7DC8-45C5-BFDE-2F4EB217B3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6ADB8-FBB7-4FB2-BF07-8F60EC503F82}" type="datetimeFigureOut">
              <a:rPr lang="en-US" smtClean="0"/>
              <a:t>1/5/2021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4B0D6B-14A5-4F09-B090-3CCBC85CFA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A310A8-92FE-4F47-9E9D-B7EA57036C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FE69E-B43D-454B-A668-8D6B6FB3F02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515600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D21561-DFFB-4E6F-A135-04AB94756D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57D1696-5ADD-4E74-A686-8D6F0ADB10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761D7E-9245-4AFF-AED4-6747E177A3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6ADB8-FBB7-4FB2-BF07-8F60EC503F82}" type="datetimeFigureOut">
              <a:rPr lang="en-US" smtClean="0"/>
              <a:t>1/5/2021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612246-FAE3-48AF-BB6E-23E17B6BE6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5F6C52-FE07-4181-8963-17F172F759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FE69E-B43D-454B-A668-8D6B6FB3F02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659501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87C577B-DC09-434F-8544-26BF0032A8B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5FB74B6-AAF5-447B-8BF0-A69D7F7663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E4597F-BA65-48D1-B607-89C5B26B6B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6ADB8-FBB7-4FB2-BF07-8F60EC503F82}" type="datetimeFigureOut">
              <a:rPr lang="en-US" smtClean="0"/>
              <a:t>1/5/2021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CBA13D-8580-4564-86C4-04E79DC3F1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DE88C5-1381-4C9B-B043-15E63F77CF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FE69E-B43D-454B-A668-8D6B6FB3F02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120436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4FDC9A-C4C5-42EE-BE16-90C31F3A16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0671E5-14F2-4F49-998D-8AE183FB2F5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5703AC-468F-498A-9AA0-50EE8E3B2A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6ADB8-FBB7-4FB2-BF07-8F60EC503F82}" type="datetimeFigureOut">
              <a:rPr lang="en-US" smtClean="0"/>
              <a:t>1/5/2021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564E99-DA2B-4319-A733-83154F4D53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B64667-77D4-4EA8-9808-1D3BB575DF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FE69E-B43D-454B-A668-8D6B6FB3F02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659380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07E5E9-88D1-4DBA-B639-A084D0CD12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B7DABF-5B03-4188-8E89-E540CA8F1F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1D7607-DAB7-4753-9D1A-EE1F2419E5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6ADB8-FBB7-4FB2-BF07-8F60EC503F82}" type="datetimeFigureOut">
              <a:rPr lang="en-US" smtClean="0"/>
              <a:t>1/5/2021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D34C81-F33E-4F55-9E97-96B3F5AB7C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F38743-5B31-41E7-9794-86FC6713CF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FE69E-B43D-454B-A668-8D6B6FB3F02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003769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8DBED3-5084-4351-8530-7EA7D787BA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0A779F-210E-442F-8782-6E6246B712F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0959B93-4522-454D-A834-F15DAB4BB1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35CC4A3-815F-4013-BFC6-689C58E6C4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6ADB8-FBB7-4FB2-BF07-8F60EC503F82}" type="datetimeFigureOut">
              <a:rPr lang="en-US" smtClean="0"/>
              <a:t>1/5/2021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BA54716-9687-4D84-AD87-0196AF4396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136672D-86CE-4D91-8645-FF10D5B61B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FE69E-B43D-454B-A668-8D6B6FB3F02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983408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FB40D2-CC0D-4E6E-B389-6FD0CCC413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7A1F4B6-355C-47DF-BE72-C59C819A79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7AE44AF-1189-479E-8140-E7BF1BE624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8ADAA6E-0A7E-42A4-A9D6-EBB0C30419E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411A3AC-DE9C-478D-ABF0-C12381F8434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85446CF-477E-40E4-BE66-9B5BCF96D8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6ADB8-FBB7-4FB2-BF07-8F60EC503F82}" type="datetimeFigureOut">
              <a:rPr lang="en-US" smtClean="0"/>
              <a:t>1/5/2021</a:t>
            </a:fld>
            <a:endParaRPr lang="en-US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4F2EFE1-6433-4FD3-9EB1-64E8180202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DCCF3DD-440C-49E7-B08E-BC05DB71D5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FE69E-B43D-454B-A668-8D6B6FB3F02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800830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F5C5D4-4C57-4709-B961-F8631D017A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FF8EF70-79AB-4EE2-838E-6E7699E6D1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6ADB8-FBB7-4FB2-BF07-8F60EC503F82}" type="datetimeFigureOut">
              <a:rPr lang="en-US" smtClean="0"/>
              <a:t>1/5/2021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21D9A65-F50A-4678-A79A-5A2C72AE8A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B8FB786-E03D-4601-93FE-944AF7B2C4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FE69E-B43D-454B-A668-8D6B6FB3F02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47905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DD5F09E-8D33-4B4C-82A1-AB8F91AE0B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6ADB8-FBB7-4FB2-BF07-8F60EC503F82}" type="datetimeFigureOut">
              <a:rPr lang="en-US" smtClean="0"/>
              <a:t>1/5/2021</a:t>
            </a:fld>
            <a:endParaRPr lang="en-US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FC3C722-2CA5-4053-8F74-5833BB5BA8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18029F6-EE5B-4FD5-A455-3A5AB03DEB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FE69E-B43D-454B-A668-8D6B6FB3F02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959805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58603E-9E5A-45E2-B6B3-3B957A03E2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EDC872-8A49-4B73-B916-FEAD7D3D0D7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DD3146E-ABED-4C7F-AC80-E37C06D456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34E39BB-1020-4073-92B6-4FF1A0592F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6ADB8-FBB7-4FB2-BF07-8F60EC503F82}" type="datetimeFigureOut">
              <a:rPr lang="en-US" smtClean="0"/>
              <a:t>1/5/2021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70E787F-0F3E-41F3-B856-A092085A73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198AEC-22D2-48D1-9849-73CFE6686F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FE69E-B43D-454B-A668-8D6B6FB3F02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66628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43B77A-877D-4A43-9A62-DB84A92D4F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5D5BC01-316E-415D-A739-9D61A27BDD4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A2A88E2-C95B-4E3E-856F-D348089AB7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B694407-065A-429D-B09C-F122C344DA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6ADB8-FBB7-4FB2-BF07-8F60EC503F82}" type="datetimeFigureOut">
              <a:rPr lang="en-US" smtClean="0"/>
              <a:t>1/5/2021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554B571-5A10-4988-8A9F-14A67665ED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6F1578-EC8C-45BE-B750-F79C023B21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6FE69E-B43D-454B-A668-8D6B6FB3F02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275307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0A67F8B-E050-41E9-BD18-D76D970735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195723F-A03A-4FAC-ACED-7A4FC676DB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6524C3-FB17-489B-BF14-6C49082FC3F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C6ADB8-FBB7-4FB2-BF07-8F60EC503F82}" type="datetimeFigureOut">
              <a:rPr lang="en-US" smtClean="0"/>
              <a:t>1/5/2021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71CBA2-BD14-4FCD-8654-9FC62DFAE99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9032FD-37C9-4CC7-ADDA-7727BA14FCC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6FE69E-B43D-454B-A668-8D6B6FB3F02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31734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extBox 38">
            <a:extLst>
              <a:ext uri="{FF2B5EF4-FFF2-40B4-BE49-F238E27FC236}">
                <a16:creationId xmlns:a16="http://schemas.microsoft.com/office/drawing/2014/main" id="{99FE355D-DAAD-440F-8F5C-80B97313A7C1}"/>
              </a:ext>
            </a:extLst>
          </p:cNvPr>
          <p:cNvSpPr txBox="1"/>
          <p:nvPr/>
        </p:nvSpPr>
        <p:spPr>
          <a:xfrm>
            <a:off x="0" y="99178"/>
            <a:ext cx="12192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/>
              <a:t>Fatty acid metabolism in the </a:t>
            </a:r>
            <a:r>
              <a:rPr lang="en-US" sz="2000" dirty="0">
                <a:solidFill>
                  <a:srgbClr val="C00000"/>
                </a:solidFill>
              </a:rPr>
              <a:t>Pirc rat</a:t>
            </a:r>
            <a:r>
              <a:rPr lang="en-US" sz="2000" dirty="0"/>
              <a:t> ± </a:t>
            </a:r>
            <a:r>
              <a:rPr lang="en-US" sz="2000" dirty="0">
                <a:solidFill>
                  <a:srgbClr val="009A46"/>
                </a:solidFill>
              </a:rPr>
              <a:t>dietary spinach (SPI)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1996CF4-4096-4A3D-92C5-F1A20873B75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833"/>
          <a:stretch/>
        </p:blipFill>
        <p:spPr>
          <a:xfrm>
            <a:off x="2012626" y="649760"/>
            <a:ext cx="1993861" cy="217202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A37CE4E-582C-426D-9159-A0220974AAF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31262" y="4453754"/>
            <a:ext cx="1962900" cy="2198201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959E60EA-C892-4B73-AFC4-8D15A08AF83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1828" y="2942545"/>
            <a:ext cx="2018629" cy="2192009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D2243156-E60D-4260-BAFD-00F2B487D93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122708" y="4350329"/>
            <a:ext cx="1870018" cy="234061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F9EA2CFA-A9E3-4D02-AD87-F6B5262B998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290002" y="4671467"/>
            <a:ext cx="2012437" cy="188240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8AEEA8D-D20B-4C59-B2AB-3D71CC02F8C6}"/>
              </a:ext>
            </a:extLst>
          </p:cNvPr>
          <p:cNvSpPr txBox="1"/>
          <p:nvPr/>
        </p:nvSpPr>
        <p:spPr>
          <a:xfrm>
            <a:off x="6059283" y="2238779"/>
            <a:ext cx="1683628" cy="1692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embrane phospholipids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CF8F643-C6E3-4C57-B774-2D4721C76418}"/>
              </a:ext>
            </a:extLst>
          </p:cNvPr>
          <p:cNvSpPr txBox="1"/>
          <p:nvPr/>
        </p:nvSpPr>
        <p:spPr>
          <a:xfrm>
            <a:off x="5001783" y="2641777"/>
            <a:ext cx="1094609" cy="1692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rachidonate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10E079F5-CFEE-4A23-84F9-0A4DEDAEB34B}"/>
              </a:ext>
            </a:extLst>
          </p:cNvPr>
          <p:cNvCxnSpPr>
            <a:cxnSpLocks/>
          </p:cNvCxnSpPr>
          <p:nvPr/>
        </p:nvCxnSpPr>
        <p:spPr>
          <a:xfrm>
            <a:off x="5461213" y="1967453"/>
            <a:ext cx="0" cy="64008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2CF4BF0D-CFEC-4C6B-A240-2CC92548CFCF}"/>
              </a:ext>
            </a:extLst>
          </p:cNvPr>
          <p:cNvSpPr txBox="1"/>
          <p:nvPr/>
        </p:nvSpPr>
        <p:spPr>
          <a:xfrm>
            <a:off x="3874362" y="2873360"/>
            <a:ext cx="680034" cy="1692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-HPETE</a:t>
            </a:r>
          </a:p>
        </p:txBody>
      </p: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40F43A5A-D673-4482-B3DA-A23206CF1DFB}"/>
              </a:ext>
            </a:extLst>
          </p:cNvPr>
          <p:cNvCxnSpPr>
            <a:cxnSpLocks/>
          </p:cNvCxnSpPr>
          <p:nvPr/>
        </p:nvCxnSpPr>
        <p:spPr>
          <a:xfrm flipH="1">
            <a:off x="4531705" y="2749499"/>
            <a:ext cx="560999" cy="157445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5D72214B-E427-40CF-A912-5434492363A2}"/>
              </a:ext>
            </a:extLst>
          </p:cNvPr>
          <p:cNvSpPr txBox="1"/>
          <p:nvPr/>
        </p:nvSpPr>
        <p:spPr>
          <a:xfrm>
            <a:off x="4448270" y="2607332"/>
            <a:ext cx="548466" cy="1692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-LOX</a:t>
            </a:r>
          </a:p>
        </p:txBody>
      </p: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21FCAC08-F5FC-471C-AC19-31AC9076E25E}"/>
              </a:ext>
            </a:extLst>
          </p:cNvPr>
          <p:cNvCxnSpPr>
            <a:cxnSpLocks/>
          </p:cNvCxnSpPr>
          <p:nvPr/>
        </p:nvCxnSpPr>
        <p:spPr>
          <a:xfrm>
            <a:off x="6040243" y="2728862"/>
            <a:ext cx="560999" cy="157445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14B7D6BA-EC4D-4BEF-9FCB-3E0FC8CEB8CF}"/>
              </a:ext>
            </a:extLst>
          </p:cNvPr>
          <p:cNvSpPr txBox="1"/>
          <p:nvPr/>
        </p:nvSpPr>
        <p:spPr>
          <a:xfrm>
            <a:off x="4698184" y="3014666"/>
            <a:ext cx="1524853" cy="1692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ycloendoperoxides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4E97333-B533-48E4-8956-380A2044889E}"/>
              </a:ext>
            </a:extLst>
          </p:cNvPr>
          <p:cNvSpPr txBox="1"/>
          <p:nvPr/>
        </p:nvSpPr>
        <p:spPr>
          <a:xfrm>
            <a:off x="5496879" y="2838153"/>
            <a:ext cx="385754" cy="1692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X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CCDD028-2A66-4712-BCA6-FF2C55D5D6FE}"/>
              </a:ext>
            </a:extLst>
          </p:cNvPr>
          <p:cNvSpPr txBox="1"/>
          <p:nvPr/>
        </p:nvSpPr>
        <p:spPr>
          <a:xfrm>
            <a:off x="2347556" y="3095806"/>
            <a:ext cx="1075766" cy="50783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eukotrienes (e.g., LTA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pro-inflammatory)</a:t>
            </a:r>
          </a:p>
        </p:txBody>
      </p: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AC6C6894-7908-4001-A7EC-4D6F4943FD0B}"/>
              </a:ext>
            </a:extLst>
          </p:cNvPr>
          <p:cNvCxnSpPr>
            <a:cxnSpLocks/>
          </p:cNvCxnSpPr>
          <p:nvPr/>
        </p:nvCxnSpPr>
        <p:spPr>
          <a:xfrm>
            <a:off x="5840756" y="3238229"/>
            <a:ext cx="560999" cy="157445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29BECE2D-A500-4F89-9AFE-FD92B257AC73}"/>
              </a:ext>
            </a:extLst>
          </p:cNvPr>
          <p:cNvCxnSpPr>
            <a:cxnSpLocks/>
          </p:cNvCxnSpPr>
          <p:nvPr/>
        </p:nvCxnSpPr>
        <p:spPr>
          <a:xfrm flipH="1">
            <a:off x="4549506" y="3245031"/>
            <a:ext cx="560999" cy="157445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C1B4394C-4322-4040-A5D8-A0D5DD779464}"/>
              </a:ext>
            </a:extLst>
          </p:cNvPr>
          <p:cNvCxnSpPr>
            <a:cxnSpLocks/>
          </p:cNvCxnSpPr>
          <p:nvPr/>
        </p:nvCxnSpPr>
        <p:spPr>
          <a:xfrm>
            <a:off x="5462084" y="3226722"/>
            <a:ext cx="0" cy="316712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C15325C6-B69C-4A67-A3FC-7E227F9CEF55}"/>
              </a:ext>
            </a:extLst>
          </p:cNvPr>
          <p:cNvSpPr txBox="1"/>
          <p:nvPr/>
        </p:nvSpPr>
        <p:spPr>
          <a:xfrm>
            <a:off x="4844714" y="3578300"/>
            <a:ext cx="1094609" cy="1692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hromboxanes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B6B208AD-9F73-4F15-B003-08AEBC2F1175}"/>
              </a:ext>
            </a:extLst>
          </p:cNvPr>
          <p:cNvSpPr txBox="1"/>
          <p:nvPr/>
        </p:nvSpPr>
        <p:spPr>
          <a:xfrm>
            <a:off x="5949071" y="3435712"/>
            <a:ext cx="1094609" cy="50783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rostaglandins  (inflammatory, e.g., PGE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3EC886E8-8ABE-4313-A8A4-1E431A0E2E07}"/>
              </a:ext>
            </a:extLst>
          </p:cNvPr>
          <p:cNvSpPr txBox="1"/>
          <p:nvPr/>
        </p:nvSpPr>
        <p:spPr>
          <a:xfrm>
            <a:off x="3715696" y="3395674"/>
            <a:ext cx="919526" cy="1692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rostacyclin</a:t>
            </a:r>
          </a:p>
        </p:txBody>
      </p: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DFC2C39D-2B90-4A07-8F3D-8C3FFA6671EA}"/>
              </a:ext>
            </a:extLst>
          </p:cNvPr>
          <p:cNvCxnSpPr>
            <a:cxnSpLocks/>
          </p:cNvCxnSpPr>
          <p:nvPr/>
        </p:nvCxnSpPr>
        <p:spPr>
          <a:xfrm>
            <a:off x="4160366" y="3569911"/>
            <a:ext cx="0" cy="18288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DC6B1BFD-B1BC-46CB-B636-A13908DFBB0B}"/>
              </a:ext>
            </a:extLst>
          </p:cNvPr>
          <p:cNvCxnSpPr>
            <a:cxnSpLocks/>
          </p:cNvCxnSpPr>
          <p:nvPr/>
        </p:nvCxnSpPr>
        <p:spPr>
          <a:xfrm>
            <a:off x="4158508" y="4139199"/>
            <a:ext cx="0" cy="18288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28DE59BF-0B1B-4FD6-BEDE-34F9615FB684}"/>
              </a:ext>
            </a:extLst>
          </p:cNvPr>
          <p:cNvSpPr txBox="1"/>
          <p:nvPr/>
        </p:nvSpPr>
        <p:spPr>
          <a:xfrm>
            <a:off x="5605467" y="2274359"/>
            <a:ext cx="385754" cy="1692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</a:t>
            </a:r>
            <a:r>
              <a:rPr lang="en-US" sz="1100" baseline="-250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18929EAC-9680-4168-832F-2ECC9F671631}"/>
              </a:ext>
            </a:extLst>
          </p:cNvPr>
          <p:cNvCxnSpPr>
            <a:cxnSpLocks/>
          </p:cNvCxnSpPr>
          <p:nvPr/>
        </p:nvCxnSpPr>
        <p:spPr>
          <a:xfrm>
            <a:off x="5461213" y="2809084"/>
            <a:ext cx="0" cy="18288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A2667895-52EF-4507-BEFA-2C8F1C4F975B}"/>
              </a:ext>
            </a:extLst>
          </p:cNvPr>
          <p:cNvSpPr txBox="1"/>
          <p:nvPr/>
        </p:nvSpPr>
        <p:spPr>
          <a:xfrm>
            <a:off x="6208878" y="2610978"/>
            <a:ext cx="385754" cy="1692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YP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6DB3D7B9-81D3-4A41-B3F7-66AC45434019}"/>
              </a:ext>
            </a:extLst>
          </p:cNvPr>
          <p:cNvSpPr txBox="1"/>
          <p:nvPr/>
        </p:nvSpPr>
        <p:spPr>
          <a:xfrm>
            <a:off x="6669433" y="2824688"/>
            <a:ext cx="1021676" cy="1692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HETEs, DHETs</a:t>
            </a:r>
          </a:p>
        </p:txBody>
      </p: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FF62AA1B-426B-46B6-A40B-C81C09170007}"/>
              </a:ext>
            </a:extLst>
          </p:cNvPr>
          <p:cNvCxnSpPr>
            <a:cxnSpLocks/>
          </p:cNvCxnSpPr>
          <p:nvPr/>
        </p:nvCxnSpPr>
        <p:spPr>
          <a:xfrm flipH="1">
            <a:off x="3336054" y="3017751"/>
            <a:ext cx="560999" cy="157445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9147BF77-C649-4720-8A58-FA1CAB0E9584}"/>
              </a:ext>
            </a:extLst>
          </p:cNvPr>
          <p:cNvCxnSpPr>
            <a:cxnSpLocks/>
          </p:cNvCxnSpPr>
          <p:nvPr/>
        </p:nvCxnSpPr>
        <p:spPr>
          <a:xfrm>
            <a:off x="7730271" y="2941644"/>
            <a:ext cx="560999" cy="157445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id="{FC55AEE8-82D6-46B4-BC20-D148DB51CFC7}"/>
              </a:ext>
            </a:extLst>
          </p:cNvPr>
          <p:cNvSpPr txBox="1"/>
          <p:nvPr/>
        </p:nvSpPr>
        <p:spPr>
          <a:xfrm>
            <a:off x="4683162" y="1771446"/>
            <a:ext cx="1491054" cy="1692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inolenate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│</a:t>
            </a:r>
            <a:r>
              <a:rPr lang="en-US" sz="1100" b="1" dirty="0">
                <a:solidFill>
                  <a:srgbClr val="009A4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noleate</a:t>
            </a:r>
          </a:p>
        </p:txBody>
      </p: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01B2B26E-FE7F-4BCD-BD49-64A75A4C5817}"/>
              </a:ext>
            </a:extLst>
          </p:cNvPr>
          <p:cNvCxnSpPr>
            <a:cxnSpLocks/>
          </p:cNvCxnSpPr>
          <p:nvPr/>
        </p:nvCxnSpPr>
        <p:spPr>
          <a:xfrm flipH="1">
            <a:off x="5588689" y="2404783"/>
            <a:ext cx="560999" cy="157445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21B2DAEE-D78E-4A74-93BB-2F439AF8B4A7}"/>
              </a:ext>
            </a:extLst>
          </p:cNvPr>
          <p:cNvSpPr txBox="1"/>
          <p:nvPr/>
        </p:nvSpPr>
        <p:spPr>
          <a:xfrm>
            <a:off x="4611979" y="2147301"/>
            <a:ext cx="828897" cy="1692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saturases</a:t>
            </a:r>
            <a:endParaRPr lang="en-US" sz="1100" baseline="-25000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762B5A1B-1158-4416-9AAA-5FEEA5380CDF}"/>
              </a:ext>
            </a:extLst>
          </p:cNvPr>
          <p:cNvSpPr txBox="1"/>
          <p:nvPr/>
        </p:nvSpPr>
        <p:spPr>
          <a:xfrm>
            <a:off x="6088112" y="1695426"/>
            <a:ext cx="674731" cy="1692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-LOX-1</a:t>
            </a:r>
          </a:p>
        </p:txBody>
      </p:sp>
      <p:cxnSp>
        <p:nvCxnSpPr>
          <p:cNvPr id="72" name="Straight Arrow Connector 71">
            <a:extLst>
              <a:ext uri="{FF2B5EF4-FFF2-40B4-BE49-F238E27FC236}">
                <a16:creationId xmlns:a16="http://schemas.microsoft.com/office/drawing/2014/main" id="{388A96A0-EBB8-47F4-AF3B-5C5E575C6EA8}"/>
              </a:ext>
            </a:extLst>
          </p:cNvPr>
          <p:cNvCxnSpPr>
            <a:cxnSpLocks/>
          </p:cNvCxnSpPr>
          <p:nvPr/>
        </p:nvCxnSpPr>
        <p:spPr>
          <a:xfrm rot="5400000">
            <a:off x="4385816" y="1542036"/>
            <a:ext cx="0" cy="64008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Arrow Connector 72">
            <a:extLst>
              <a:ext uri="{FF2B5EF4-FFF2-40B4-BE49-F238E27FC236}">
                <a16:creationId xmlns:a16="http://schemas.microsoft.com/office/drawing/2014/main" id="{A64762C1-8A57-4251-9232-2A6F2F3A9E87}"/>
              </a:ext>
            </a:extLst>
          </p:cNvPr>
          <p:cNvCxnSpPr>
            <a:cxnSpLocks/>
          </p:cNvCxnSpPr>
          <p:nvPr/>
        </p:nvCxnSpPr>
        <p:spPr>
          <a:xfrm rot="16200000" flipH="1">
            <a:off x="6461751" y="1548644"/>
            <a:ext cx="0" cy="64008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82F1A3C4-A2E3-46B1-B8D4-8A60A43C76D2}"/>
              </a:ext>
            </a:extLst>
          </p:cNvPr>
          <p:cNvSpPr txBox="1"/>
          <p:nvPr/>
        </p:nvSpPr>
        <p:spPr>
          <a:xfrm>
            <a:off x="6741323" y="1784046"/>
            <a:ext cx="777761" cy="1692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b="1" dirty="0">
                <a:solidFill>
                  <a:srgbClr val="009A4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-HPODE</a:t>
            </a:r>
          </a:p>
        </p:txBody>
      </p:sp>
      <p:cxnSp>
        <p:nvCxnSpPr>
          <p:cNvPr id="76" name="Straight Arrow Connector 75">
            <a:extLst>
              <a:ext uri="{FF2B5EF4-FFF2-40B4-BE49-F238E27FC236}">
                <a16:creationId xmlns:a16="http://schemas.microsoft.com/office/drawing/2014/main" id="{17688097-CF55-4A13-BF3C-F126B4D43445}"/>
              </a:ext>
            </a:extLst>
          </p:cNvPr>
          <p:cNvCxnSpPr>
            <a:cxnSpLocks/>
          </p:cNvCxnSpPr>
          <p:nvPr/>
        </p:nvCxnSpPr>
        <p:spPr>
          <a:xfrm>
            <a:off x="7505248" y="1868455"/>
            <a:ext cx="457200" cy="459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Arrow Connector 76">
            <a:extLst>
              <a:ext uri="{FF2B5EF4-FFF2-40B4-BE49-F238E27FC236}">
                <a16:creationId xmlns:a16="http://schemas.microsoft.com/office/drawing/2014/main" id="{648DC3E8-D6E3-4180-8AE7-0E2A962B7847}"/>
              </a:ext>
            </a:extLst>
          </p:cNvPr>
          <p:cNvCxnSpPr>
            <a:cxnSpLocks/>
          </p:cNvCxnSpPr>
          <p:nvPr/>
        </p:nvCxnSpPr>
        <p:spPr>
          <a:xfrm rot="16200000" flipH="1">
            <a:off x="9178037" y="1320044"/>
            <a:ext cx="0" cy="109728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:a16="http://schemas.microsoft.com/office/drawing/2014/main" id="{25DBD7C4-A7D4-45BA-9A5D-C489C8165FAE}"/>
              </a:ext>
            </a:extLst>
          </p:cNvPr>
          <p:cNvSpPr txBox="1"/>
          <p:nvPr/>
        </p:nvSpPr>
        <p:spPr>
          <a:xfrm>
            <a:off x="7931290" y="1784046"/>
            <a:ext cx="714839" cy="1692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3-HODE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0E7E56B3-8EF1-46E8-BE14-3CBF72C91FD8}"/>
              </a:ext>
            </a:extLst>
          </p:cNvPr>
          <p:cNvSpPr txBox="1"/>
          <p:nvPr/>
        </p:nvSpPr>
        <p:spPr>
          <a:xfrm>
            <a:off x="7485530" y="1695426"/>
            <a:ext cx="447494" cy="1692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Px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402A0731-7CE0-4A28-856B-34B8E701C844}"/>
              </a:ext>
            </a:extLst>
          </p:cNvPr>
          <p:cNvSpPr txBox="1"/>
          <p:nvPr/>
        </p:nvSpPr>
        <p:spPr>
          <a:xfrm>
            <a:off x="8602316" y="1695426"/>
            <a:ext cx="1084493" cy="1692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hydrogenase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A1665310-44E4-4568-AD4E-D6B5B73B25A5}"/>
              </a:ext>
            </a:extLst>
          </p:cNvPr>
          <p:cNvSpPr txBox="1"/>
          <p:nvPr/>
        </p:nvSpPr>
        <p:spPr>
          <a:xfrm>
            <a:off x="4147708" y="1694577"/>
            <a:ext cx="566904" cy="1692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-LOX</a:t>
            </a:r>
          </a:p>
        </p:txBody>
      </p:sp>
      <p:pic>
        <p:nvPicPr>
          <p:cNvPr id="85" name="Picture 84">
            <a:extLst>
              <a:ext uri="{FF2B5EF4-FFF2-40B4-BE49-F238E27FC236}">
                <a16:creationId xmlns:a16="http://schemas.microsoft.com/office/drawing/2014/main" id="{C91D219F-18CF-46B9-A000-A6CC8115BF7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799654" y="495123"/>
            <a:ext cx="1944324" cy="2322043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9E3823CF-182F-40EF-9606-57D317E6DA7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288219" y="2670177"/>
            <a:ext cx="1944324" cy="1938132"/>
          </a:xfrm>
          <a:prstGeom prst="rect">
            <a:avLst/>
          </a:prstGeom>
        </p:spPr>
      </p:pic>
      <p:sp>
        <p:nvSpPr>
          <p:cNvPr id="52" name="TextBox 51">
            <a:extLst>
              <a:ext uri="{FF2B5EF4-FFF2-40B4-BE49-F238E27FC236}">
                <a16:creationId xmlns:a16="http://schemas.microsoft.com/office/drawing/2014/main" id="{BC43B0EA-4B7E-4AB5-BEF9-C837392B1853}"/>
              </a:ext>
            </a:extLst>
          </p:cNvPr>
          <p:cNvSpPr txBox="1"/>
          <p:nvPr/>
        </p:nvSpPr>
        <p:spPr>
          <a:xfrm>
            <a:off x="7837400" y="1954218"/>
            <a:ext cx="929581" cy="16927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pro-apoptotic)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D8A9FD7E-BB35-4258-9C6E-D0F2E2497F10}"/>
              </a:ext>
            </a:extLst>
          </p:cNvPr>
          <p:cNvSpPr txBox="1"/>
          <p:nvPr/>
        </p:nvSpPr>
        <p:spPr>
          <a:xfrm>
            <a:off x="10578141" y="493638"/>
            <a:ext cx="777761" cy="169277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b="1" dirty="0">
                <a:solidFill>
                  <a:srgbClr val="009A4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-oxoODE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279D10D8-8239-4313-850E-9EDB3B12D3A6}"/>
              </a:ext>
            </a:extLst>
          </p:cNvPr>
          <p:cNvSpPr txBox="1"/>
          <p:nvPr/>
        </p:nvSpPr>
        <p:spPr>
          <a:xfrm>
            <a:off x="9117904" y="2832648"/>
            <a:ext cx="777761" cy="169277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b="1" dirty="0">
                <a:solidFill>
                  <a:srgbClr val="009A4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(S)-HETE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92E0FC92-C64F-47DD-A59E-60E02DF42CCC}"/>
              </a:ext>
            </a:extLst>
          </p:cNvPr>
          <p:cNvSpPr txBox="1"/>
          <p:nvPr/>
        </p:nvSpPr>
        <p:spPr>
          <a:xfrm>
            <a:off x="2829691" y="676859"/>
            <a:ext cx="777761" cy="169277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b="1" dirty="0">
                <a:solidFill>
                  <a:srgbClr val="009A4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(S)-HPOT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4B5D9972-B8BB-46A0-BBC1-D29D5ED5C664}"/>
              </a:ext>
            </a:extLst>
          </p:cNvPr>
          <p:cNvSpPr txBox="1"/>
          <p:nvPr/>
        </p:nvSpPr>
        <p:spPr>
          <a:xfrm>
            <a:off x="3580928" y="3800645"/>
            <a:ext cx="1189062" cy="33855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6-keto-PGF1</a:t>
            </a:r>
            <a:r>
              <a:rPr lang="en-US" sz="1100" dirty="0">
                <a:latin typeface="Symbol" panose="05050102010706020507" pitchFamily="18" charset="2"/>
              </a:rPr>
              <a:t>a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anticancer)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3710E381-33B5-4DD6-9573-F9DA18959083}"/>
              </a:ext>
            </a:extLst>
          </p:cNvPr>
          <p:cNvSpPr txBox="1"/>
          <p:nvPr/>
        </p:nvSpPr>
        <p:spPr>
          <a:xfrm>
            <a:off x="1267700" y="2990354"/>
            <a:ext cx="968638" cy="338554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eukotriene A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BD3D4FA9-3FAE-4BD2-B053-7DD8AEBEE41D}"/>
              </a:ext>
            </a:extLst>
          </p:cNvPr>
          <p:cNvSpPr txBox="1"/>
          <p:nvPr/>
        </p:nvSpPr>
        <p:spPr>
          <a:xfrm>
            <a:off x="3680289" y="4332353"/>
            <a:ext cx="968638" cy="169277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6-keto-PGE1</a:t>
            </a:r>
            <a:endParaRPr lang="en-US" sz="11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BCD7F99F-760F-4C6E-8507-F90FF3CC35D9}"/>
              </a:ext>
            </a:extLst>
          </p:cNvPr>
          <p:cNvSpPr txBox="1"/>
          <p:nvPr/>
        </p:nvSpPr>
        <p:spPr>
          <a:xfrm>
            <a:off x="5866968" y="4495028"/>
            <a:ext cx="1340993" cy="169277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GE2 Ethanolamine</a:t>
            </a:r>
            <a:endParaRPr lang="en-US" sz="11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" name="Straight Arrow Connector 73">
            <a:extLst>
              <a:ext uri="{FF2B5EF4-FFF2-40B4-BE49-F238E27FC236}">
                <a16:creationId xmlns:a16="http://schemas.microsoft.com/office/drawing/2014/main" id="{F026D654-FA68-4698-9EC0-21B7ADFEE98E}"/>
              </a:ext>
            </a:extLst>
          </p:cNvPr>
          <p:cNvCxnSpPr>
            <a:cxnSpLocks/>
          </p:cNvCxnSpPr>
          <p:nvPr/>
        </p:nvCxnSpPr>
        <p:spPr>
          <a:xfrm>
            <a:off x="6477509" y="3954474"/>
            <a:ext cx="0" cy="45720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>
            <a:extLst>
              <a:ext uri="{FF2B5EF4-FFF2-40B4-BE49-F238E27FC236}">
                <a16:creationId xmlns:a16="http://schemas.microsoft.com/office/drawing/2014/main" id="{5E23A1FE-CEF6-49F1-9A21-02E368C0E857}"/>
              </a:ext>
            </a:extLst>
          </p:cNvPr>
          <p:cNvSpPr txBox="1"/>
          <p:nvPr/>
        </p:nvSpPr>
        <p:spPr>
          <a:xfrm>
            <a:off x="9045986" y="4771587"/>
            <a:ext cx="968638" cy="169277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8,9-DHET</a:t>
            </a:r>
            <a:endParaRPr lang="en-US" sz="11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99FF7E87-CC8E-4052-A8C7-9C1502C2C300}"/>
              </a:ext>
            </a:extLst>
          </p:cNvPr>
          <p:cNvSpPr txBox="1"/>
          <p:nvPr/>
        </p:nvSpPr>
        <p:spPr>
          <a:xfrm>
            <a:off x="258386" y="6343370"/>
            <a:ext cx="1977952" cy="338554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alytes in rat tissues that were </a:t>
            </a:r>
            <a:r>
              <a:rPr lang="en-US" sz="1100" b="1" dirty="0">
                <a:solidFill>
                  <a:srgbClr val="009A4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so detected i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>
                <a:solidFill>
                  <a:srgbClr val="009A4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inach</a:t>
            </a:r>
          </a:p>
        </p:txBody>
      </p:sp>
    </p:spTree>
    <p:extLst>
      <p:ext uri="{BB962C8B-B14F-4D97-AF65-F5344CB8AC3E}">
        <p14:creationId xmlns:p14="http://schemas.microsoft.com/office/powerpoint/2010/main" val="8072743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05</TotalTime>
  <Words>91</Words>
  <Application>Microsoft Office PowerPoint</Application>
  <PresentationFormat>Widescreen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shwood, Roderick H.</dc:creator>
  <cp:lastModifiedBy>Dashwood, Roderick H.</cp:lastModifiedBy>
  <cp:revision>171</cp:revision>
  <dcterms:created xsi:type="dcterms:W3CDTF">2020-11-22T18:02:11Z</dcterms:created>
  <dcterms:modified xsi:type="dcterms:W3CDTF">2021-01-05T21:02:06Z</dcterms:modified>
</cp:coreProperties>
</file>